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3656843-2291-46DE-8E71-71B6B24E8B7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4AD1B72-F844-4AFA-A348-03C9DF3C121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69E8F-23C5-4CD3-9C75-B367C06B10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00169A-6AF6-4ECC-B230-2E787B78AC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24AA9-7C32-4E26-A81E-9737813809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723077-F53D-4940-A5C0-7DA225686B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F0BD5E-A2EE-4751-81D3-7825D1F344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90AF7-C6FA-47D6-8DF7-03866D6D23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79503-D34D-4472-9C4A-C79B22BAA0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3C40FA-7439-4EEF-9F61-068A44D7B5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1A0A4-AF5A-4C2C-861C-A8DBAF9728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F7834-FF2F-4C80-80EE-441089E245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A8E28-6BF9-455B-B22F-81EDC3796B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23B72-433D-404F-96C1-C5B8F29B17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97DFCE2-6727-41A6-B763-96B9E0DF92A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230040" y="291960"/>
            <a:ext cx="4768920" cy="32544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" descr=""/>
          <p:cNvPicPr/>
          <p:nvPr/>
        </p:nvPicPr>
        <p:blipFill>
          <a:blip r:embed="rId2"/>
          <a:stretch/>
        </p:blipFill>
        <p:spPr>
          <a:xfrm>
            <a:off x="4038480" y="291960"/>
            <a:ext cx="4767480" cy="3245040"/>
          </a:xfrm>
          <a:prstGeom prst="rect">
            <a:avLst/>
          </a:prstGeom>
          <a:ln w="0">
            <a:noFill/>
          </a:ln>
        </p:spPr>
      </p:pic>
      <p:sp>
        <p:nvSpPr>
          <p:cNvPr id="50" name="TextBox 3"/>
          <p:cNvSpPr/>
          <p:nvPr/>
        </p:nvSpPr>
        <p:spPr>
          <a:xfrm>
            <a:off x="0" y="274680"/>
            <a:ext cx="493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9"/>
          <p:cNvSpPr/>
          <p:nvPr/>
        </p:nvSpPr>
        <p:spPr>
          <a:xfrm>
            <a:off x="3774960" y="271440"/>
            <a:ext cx="493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6"/>
          <p:cNvSpPr/>
          <p:nvPr/>
        </p:nvSpPr>
        <p:spPr>
          <a:xfrm>
            <a:off x="115920" y="3595680"/>
            <a:ext cx="8913960" cy="179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Combination Treatment of Caspase-8 Knockdown Cells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A,B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, Stable 089 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(A)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 and 090 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(B)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caspase-8 (C8) and scrambled (scr) shRNA cells generated by lentiviral infection and induction with 1 mg/ml doxycycline for 24 hours were treated with 50 ng/ml TRAIL and 2.5 ng/ml Bortezomib (Btz) alone or in combination before analysis of cell viability by MTT assay at 14 and 22 hours post-treatment. Bars represent mean cell viability normalised to untreated control cells, error bars indicate SEM (N = 2)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17T16:23:04Z</dcterms:created>
  <dc:creator>Jessica Bullenkamp</dc:creator>
  <dc:description/>
  <dc:language>en-US</dc:language>
  <cp:lastModifiedBy>mn.nandini</cp:lastModifiedBy>
  <dcterms:modified xsi:type="dcterms:W3CDTF">2014-10-16T09:17:43Z</dcterms:modified>
  <cp:revision>5</cp:revision>
  <dc:subject/>
  <dc:title>PowerPoint Presentation</dc:title>
</cp:coreProperties>
</file>